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43" d="100"/>
          <a:sy n="143" d="100"/>
        </p:scale>
        <p:origin x="-112" y="-3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19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627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475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164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33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610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08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613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541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596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223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160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68376" y="5225257"/>
            <a:ext cx="948175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Additional file 7: Figure showing validation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of the 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RNAseq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-based expression by gene promoter studies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Promoters of selected gene were fused with promoter probe vector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pBBRGFP-G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and tested with similar concentration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azelai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acid which was used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RNAseq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expression studies. Significant fold change from selected genes was observed only betwee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pBGFPgen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1818/methanol 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pBGFPgen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1818/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azelai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acid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Data shown are the mean and standard deviation of experiment performed thrice in triplicate. </a:t>
            </a:r>
            <a:endParaRPr lang="en-US" sz="1200" dirty="0">
              <a:effectLst/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1011" y="416432"/>
            <a:ext cx="5319703" cy="4808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89478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83</Words>
  <Application>Microsoft Macintosh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ICGEB ICGEB</cp:lastModifiedBy>
  <cp:revision>5</cp:revision>
  <dcterms:created xsi:type="dcterms:W3CDTF">2017-06-03T12:12:18Z</dcterms:created>
  <dcterms:modified xsi:type="dcterms:W3CDTF">2018-11-01T10:20:20Z</dcterms:modified>
</cp:coreProperties>
</file>